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570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27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003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835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368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937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840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441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294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641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097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4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DB7C6-B070-4885-8200-96FE595D8566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DD5EA-C40D-421B-A069-E98E797992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078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4E14DAB-C1A9-4C60-A60D-DE00E6CD56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00" y="803275"/>
            <a:ext cx="2781300" cy="27813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CA77137-249F-41EA-8525-65572B03B3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050" y="803275"/>
            <a:ext cx="2781300" cy="27813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587E2AB-2904-4FEA-9425-C46AE05310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00" y="3759200"/>
            <a:ext cx="2781300" cy="27813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A03B0AF-9215-49B6-9ACD-A872BE1B082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050" y="3759200"/>
            <a:ext cx="2781300" cy="27813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7DBB74A-0B43-49BE-8403-E77DA1D501C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7600" y="804863"/>
            <a:ext cx="2781300" cy="27813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F9E8341-78D5-40EE-8612-467092B30B3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7600" y="3759200"/>
            <a:ext cx="2781300" cy="27813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D804800-EE16-4470-AE18-299B2BEAB9BE}"/>
              </a:ext>
            </a:extLst>
          </p:cNvPr>
          <p:cNvSpPr txBox="1"/>
          <p:nvPr/>
        </p:nvSpPr>
        <p:spPr>
          <a:xfrm>
            <a:off x="1651668" y="163611"/>
            <a:ext cx="7327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3 Fig. GSEA Analysis of STAG2-Regulated Gene Expression</a:t>
            </a:r>
          </a:p>
        </p:txBody>
      </p:sp>
    </p:spTree>
    <p:extLst>
      <p:ext uri="{BB962C8B-B14F-4D97-AF65-F5344CB8AC3E}">
        <p14:creationId xmlns:p14="http://schemas.microsoft.com/office/powerpoint/2010/main" val="1751766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5A50D6A-A2E3-401F-AC2E-B808E80D18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00" y="749298"/>
            <a:ext cx="2838452" cy="28384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1AEF9A4-3689-4D9F-9DC5-9EBF121D4C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699" y="749298"/>
            <a:ext cx="2838452" cy="283845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EC902E2-5AB5-4DEB-ABF3-4E29277F967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3148" y="749298"/>
            <a:ext cx="2838452" cy="283845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481FCB6-7E83-4689-B8E9-83CFEF82F8F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3810000"/>
            <a:ext cx="2838452" cy="283845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5B1E016-969B-4C9F-9BE8-0CAC01F9F1F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2774" y="3810000"/>
            <a:ext cx="2838452" cy="283845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AE34648-C8BB-4360-8F4A-9B66E707AFC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3148" y="3810000"/>
            <a:ext cx="2838452" cy="283845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99D097A-9954-45FC-94FF-69E5E66037AC}"/>
              </a:ext>
            </a:extLst>
          </p:cNvPr>
          <p:cNvSpPr txBox="1"/>
          <p:nvPr/>
        </p:nvSpPr>
        <p:spPr>
          <a:xfrm>
            <a:off x="1651668" y="163611"/>
            <a:ext cx="7327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3 Fig. GSEA Analysis of STAG2-dependent Gene Expression</a:t>
            </a:r>
          </a:p>
        </p:txBody>
      </p:sp>
    </p:spTree>
    <p:extLst>
      <p:ext uri="{BB962C8B-B14F-4D97-AF65-F5344CB8AC3E}">
        <p14:creationId xmlns:p14="http://schemas.microsoft.com/office/powerpoint/2010/main" val="881385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</TotalTime>
  <Words>18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gSik Kim</dc:creator>
  <cp:lastModifiedBy>JungSik Kim</cp:lastModifiedBy>
  <cp:revision>9</cp:revision>
  <dcterms:created xsi:type="dcterms:W3CDTF">2025-08-06T12:41:52Z</dcterms:created>
  <dcterms:modified xsi:type="dcterms:W3CDTF">2025-08-15T12:37:05Z</dcterms:modified>
</cp:coreProperties>
</file>